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0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62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BFE46B-60BE-AACF-26D5-A5D157B0DC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BA4A85C-CB5B-91CA-9ACE-E6DA45D2B3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044791-945A-4958-E437-FC6A14E6D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0C4B86-E4C0-3F91-316D-C1F4FF087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77A1D12-979B-9E9F-7E35-BE06E48F4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63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F61A60-D002-1383-9CE9-94FA150D24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86A8BB-A3B8-17C4-D46C-411D3D55EA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5939FC5-66CA-39A2-864D-CCA194DB4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59BAA1-0307-1247-F66C-5865A5BBB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F0311D-AA45-AD3D-DF2D-9E782FC7D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801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B863EE9-62B4-A589-CECF-BD96CB8D40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AD00F4-EAEF-C13A-83BF-DE926BF4F4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363602-3CA6-BA92-DE32-F5A39818C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D39D7A-73A4-854C-EB03-588197216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5FD0E4-5C56-A3A3-FF58-B61398624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681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6863CA-E7D2-73A3-B603-EB9ACBE9D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5A9113-0384-DA7C-B750-E7C40831F5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4975DD-E0DA-B6A9-8757-D5473C378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AE5E87-A62A-4BA5-6B73-76647A3F6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321D1A-6DCC-EF80-0DCD-1D71AF124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367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663CE2-581E-5D30-AAFA-7A764B21C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A1438F9-CFA6-A60F-5941-A3FA96BA9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1034AB0-D920-F27A-63AD-7DEE73071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A4302C-A0C8-FC68-C83A-AE994E6F15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AF668B-326B-1034-D21A-7DD2538DD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396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DDF3A3-622B-5D4B-08F6-E64364ED1D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DFEC5B2-8CEF-69D6-84B3-16499F9A36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A938DE5-9567-6ABE-C19B-5F718BF53F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09B167-D6D9-82F7-917A-D2AEB9E6F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53AADA-5530-B12A-F353-6A4030771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12CBB1-75E1-5BAC-AB89-36BF36358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044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B70B7D-4CB2-66E1-9077-CC571D02B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B34258-585C-CCD0-72CF-6B1A220FDB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3F1046-0086-8A4F-52F2-15A99759AA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9C26DD4-EF5D-F610-0A68-407B28B5BA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50E504E-70B7-4A6D-182F-648C9EA7DF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EA6A157-2A7D-41FD-524E-CB4A01FF3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02DBFCA-D420-67A6-A52C-A44509C8A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A08FAD0-9C83-DBBB-9F9D-240EA0F3E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907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956A37-3F7F-5463-585A-D48674DEA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D600A13-FBC6-96F1-15AD-131E39DF4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8D3C2B7-34BC-0F28-4A10-8E5C007AF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1F96E9C-76AA-0270-F228-9ABBADA86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9209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7B0B28D-F153-7FE7-4D1B-16301CA64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DD4D4A9-5C86-B0FF-9993-BE2913E6C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E68CB2A-150E-4DD9-EE28-413061125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638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91C7DB-25D4-C331-2FE0-4C45608F1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90A2DFA-D9BC-6127-3197-932F520258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87B3F17-2756-AC8E-9354-60FE3387AB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7FC2D1-DC14-0DA3-41E4-DCA992395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A283F0-4AD5-904E-3488-816F69444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32704A0-B252-F46E-D998-AFAF0C51F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0730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E720CC-04AB-E2D9-86E3-BC0E4D4C2C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4DC6FCA-A60A-E905-CFFE-2D403BC6F3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84FB913-BC2F-F660-B285-5D86BC0211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F72F303-D2BE-8505-4B31-2BE493692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EC7009-E136-94AF-725F-789EF0E82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80BF7BD-E6C9-1A4E-AD54-E7C7D2479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67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3AB1B67-1C44-8F0B-DB8F-065C83F4D5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7D77AA6-2697-F33F-4F96-3A9D1CC18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EA44BD-8B52-78D6-FD79-857B2AB706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62E1B-769C-4A1C-B380-3F2255A71473}" type="datetimeFigureOut">
              <a:rPr kumimoji="1" lang="ja-JP" altLang="en-US" smtClean="0"/>
              <a:t>2023/4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0F9F68-B2E1-A033-9F8A-5B74EE2E52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17BE25-94B6-B859-0851-C1558CD573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CBEE6-5A8B-4171-BE15-321935C7B1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886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3CB8EF05-85DE-D1D4-B5E1-1C9BA7FDE5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4532068"/>
              </p:ext>
            </p:extLst>
          </p:nvPr>
        </p:nvGraphicFramePr>
        <p:xfrm>
          <a:off x="947738" y="17463"/>
          <a:ext cx="10721975" cy="6583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10721446" imgH="6583680" progId="Excel.Sheet.12">
                  <p:embed/>
                </p:oleObj>
              </mc:Choice>
              <mc:Fallback>
                <p:oleObj name="Worksheet" r:id="rId2" imgW="10721446" imgH="658368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47738" y="17463"/>
                        <a:ext cx="10721975" cy="6583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7D26BE4-710A-B1BA-DEEC-2B763C395968}"/>
              </a:ext>
            </a:extLst>
          </p:cNvPr>
          <p:cNvSpPr txBox="1"/>
          <p:nvPr/>
        </p:nvSpPr>
        <p:spPr>
          <a:xfrm>
            <a:off x="894041" y="6563539"/>
            <a:ext cx="8640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: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 result of each day. - = Not examined, MSSA: Methicillin-susceptibl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phylococcus aureu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0221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19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Worksheet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依田 ゆり子</dc:creator>
  <cp:lastModifiedBy>嶋田 努</cp:lastModifiedBy>
  <cp:revision>11</cp:revision>
  <dcterms:created xsi:type="dcterms:W3CDTF">2023-01-30T11:14:18Z</dcterms:created>
  <dcterms:modified xsi:type="dcterms:W3CDTF">2023-04-03T09:02:12Z</dcterms:modified>
</cp:coreProperties>
</file>